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69" userDrawn="1">
          <p15:clr>
            <a:srgbClr val="A4A3A4"/>
          </p15:clr>
        </p15:guide>
        <p15:guide id="2" pos="46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28"/>
    <p:restoredTop sz="94665"/>
  </p:normalViewPr>
  <p:slideViewPr>
    <p:cSldViewPr snapToGrid="0" snapToObjects="1" showGuides="1">
      <p:cViewPr varScale="1">
        <p:scale>
          <a:sx n="137" d="100"/>
          <a:sy n="137" d="100"/>
        </p:scale>
        <p:origin x="248" y="192"/>
      </p:cViewPr>
      <p:guideLst>
        <p:guide orient="horz" pos="2069"/>
        <p:guide pos="46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8F8DF0-AE32-EC44-846A-797C9A11F5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70DD785-D2F8-D44F-89E7-A1FE32DF30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7793A07-B5A2-A64E-80E8-79DD9D243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9823167-024C-9C48-90C9-11CE7777D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12CAE98-BCF2-884F-8E2A-79B135751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533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CA1744F-ACD5-D74A-8975-B07EA6636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434135E-15CB-B14C-B4D3-3BD107097D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6EFFD01-E862-0743-96ED-072C4E25D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70854ED-B2EC-6C42-AC62-696687D2D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129F948-E9EF-AA4E-A36A-1DF91B82B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8987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05F781A-C6BF-0144-B544-454176A3C6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9F7FF72-46FF-5F4E-82CC-6EFB546A3C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C44BF79-5D55-084A-8A37-46CAAE880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C7448B3-C0A4-F04E-BF6D-0F004D1B4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53E5D92-5ED1-4441-BA16-A8B7549BA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424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23721F-458D-9E45-B1DE-34EBF1C3C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61FF01D-3602-A04D-8402-2CA28705B0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ECF57EC-93F3-5143-8508-E06168DB9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7C66DBA-C22A-FE41-856D-68F3D2653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543E3D-9BCB-6F4B-B95E-8BA64FCE8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3979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D2A82A-2F5E-BA4F-8F78-4F8B556EEB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E14122D-A6A9-BA4D-953A-AB4B323AA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61EF55-8C25-F14C-867F-D614AEC96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815F136-BF32-F744-B531-160855B3C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B6DDD40-508A-1A4C-9FB6-9352B86B2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5012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470D33-0C35-2740-9CF9-3FB8803BA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D889EDB-C8D9-824A-86BA-E91E466933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1EC51BB-1EAF-3747-B858-5A365F4F5F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E84ECD5-98DC-DD49-B0AA-FE2CEBAEF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B8F22D7-C8DD-4C4C-BF7A-53A6AB627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A6F8A82-36C1-3645-B16A-ACD2CF1BB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3039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8C13E26-8AD7-3D43-845F-DD76713BB5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D827106-D317-7444-BD51-39AB43B154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3CA4A24-AA69-0A41-BA2B-5949096408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A488E92-D377-844E-B256-AD70F1DE3F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3E06E24-0626-E949-A883-BB76F8BD1A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8C79EA7-90CE-AD4E-9E79-784F1961D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945ABB6-852C-D24A-9690-88C64D8ED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CDD1AE7-EE46-2747-BF26-3AB55E0A3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0285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52C9327-AC88-8145-90E9-0FE8E91D1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193B6EE-E79E-4044-A488-861789B13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5898758-B825-8441-8C30-059E49B5B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67006F8-EFBF-DC46-86F3-94B5E5D19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9938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5CCCB14-22C2-B148-92E5-C39ED47A9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D7BFE7A-E580-604E-82E1-FD28CD339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DE8427B-5276-594B-AF8D-15B759495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289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288891-59BA-3E40-941C-6B598B524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1171A5D-D1F0-4B4A-BFC8-90AFAD5ED5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F51018C-AA7D-CD4A-9FC5-A4882B7F6A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4AD3ADA-1FEA-A94E-9B21-5EFB11A02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DC8DEBE-73C2-1B41-8D43-DBECCB118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6D86B04-DAF5-8C4D-A987-DFC6C8EA8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662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D88208-5DAF-A844-BF9A-FE041B622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F8246AA-F8EC-5C44-A8A3-3EA853AE18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EC9AD79-C4BD-924C-98E8-136E063F38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B241D5-2961-C040-99FB-3C3E43CF9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3B48B36-82D7-7047-9504-19C7E8208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18483D8-1EEA-874D-819A-0E706CAF4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738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153C107-F3BE-3343-A53A-AD54B88E1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6AE2F80-A7C6-E045-8FAC-5410519B8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99A2D47-30D4-5E42-8E5B-5E85FB68BB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75B324-3D40-DA4D-9F82-3E61D6F8E564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281E69D-2F29-1945-9E78-DF41A75BA0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446E7CF-4111-5D43-B07E-D1C9E060C0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B66A5-E7CF-F749-8A4F-D2F2E1F73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237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3535" y="1017388"/>
            <a:ext cx="1927723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0888" y="1017388"/>
            <a:ext cx="1934896" cy="19873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258" y="1017388"/>
            <a:ext cx="1927727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" name="Connecteur droit avec flèche 2">
            <a:extLst>
              <a:ext uri="{FF2B5EF4-FFF2-40B4-BE49-F238E27FC236}">
                <a16:creationId xmlns:a16="http://schemas.microsoft.com/office/drawing/2014/main" id="{177A6D43-E2AC-084F-A50D-4A276B1E2C45}"/>
              </a:ext>
            </a:extLst>
          </p:cNvPr>
          <p:cNvCxnSpPr/>
          <p:nvPr/>
        </p:nvCxnSpPr>
        <p:spPr>
          <a:xfrm>
            <a:off x="5312228" y="1436914"/>
            <a:ext cx="78377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82439752-2BAA-7040-85DD-EFC077400ED1}"/>
              </a:ext>
            </a:extLst>
          </p:cNvPr>
          <p:cNvCxnSpPr>
            <a:cxnSpLocks/>
          </p:cNvCxnSpPr>
          <p:nvPr/>
        </p:nvCxnSpPr>
        <p:spPr>
          <a:xfrm>
            <a:off x="3144416" y="1436914"/>
            <a:ext cx="1977351" cy="0"/>
          </a:xfrm>
          <a:prstGeom prst="straightConnector1">
            <a:avLst/>
          </a:prstGeom>
          <a:ln w="28575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" name="Groupe 17">
            <a:extLst>
              <a:ext uri="{FF2B5EF4-FFF2-40B4-BE49-F238E27FC236}">
                <a16:creationId xmlns:a16="http://schemas.microsoft.com/office/drawing/2014/main" id="{DC082103-ED31-8E49-A8F4-92B97BA8B46D}"/>
              </a:ext>
            </a:extLst>
          </p:cNvPr>
          <p:cNvGrpSpPr/>
          <p:nvPr/>
        </p:nvGrpSpPr>
        <p:grpSpPr>
          <a:xfrm>
            <a:off x="3650663" y="3137920"/>
            <a:ext cx="1927721" cy="1980000"/>
            <a:chOff x="3707813" y="3195070"/>
            <a:chExt cx="1927721" cy="1980000"/>
          </a:xfrm>
        </p:grpSpPr>
        <p:pic>
          <p:nvPicPr>
            <p:cNvPr id="3077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7813" y="3195070"/>
              <a:ext cx="1927721" cy="198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EA2A29F9-012D-7248-ABE7-E03D93072C1A}"/>
                </a:ext>
              </a:extLst>
            </p:cNvPr>
            <p:cNvSpPr txBox="1"/>
            <p:nvPr/>
          </p:nvSpPr>
          <p:spPr>
            <a:xfrm>
              <a:off x="4014517" y="4675555"/>
              <a:ext cx="68001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D21</a:t>
              </a:r>
              <a:r>
                <a:rPr lang="fr-FR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</a:t>
              </a:r>
            </a:p>
          </p:txBody>
        </p:sp>
      </p:grp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269D7611-BA98-6847-8600-F61D267DAF8F}"/>
              </a:ext>
            </a:extLst>
          </p:cNvPr>
          <p:cNvGrpSpPr/>
          <p:nvPr/>
        </p:nvGrpSpPr>
        <p:grpSpPr>
          <a:xfrm>
            <a:off x="1752658" y="3035050"/>
            <a:ext cx="1927723" cy="2083533"/>
            <a:chOff x="1578773" y="3210044"/>
            <a:chExt cx="1927723" cy="2083533"/>
          </a:xfrm>
        </p:grpSpPr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A072F6AF-6460-FB47-8826-8E1F47EB79D7}"/>
                </a:ext>
              </a:extLst>
            </p:cNvPr>
            <p:cNvGrpSpPr/>
            <p:nvPr/>
          </p:nvGrpSpPr>
          <p:grpSpPr>
            <a:xfrm>
              <a:off x="1578773" y="3210044"/>
              <a:ext cx="1927723" cy="2083533"/>
              <a:chOff x="1578773" y="3210044"/>
              <a:chExt cx="1927723" cy="2083533"/>
            </a:xfrm>
          </p:grpSpPr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78773" y="3313577"/>
                <a:ext cx="1927723" cy="19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59C881F7-58CC-9D47-91BE-916E94956EEA}"/>
                  </a:ext>
                </a:extLst>
              </p:cNvPr>
              <p:cNvSpPr txBox="1"/>
              <p:nvPr/>
            </p:nvSpPr>
            <p:spPr>
              <a:xfrm>
                <a:off x="1968756" y="3210044"/>
                <a:ext cx="1300674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[CD21</a:t>
                </a:r>
                <a:r>
                  <a:rPr lang="fr-FR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lo</a:t>
                </a:r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] CD27  /</a:t>
                </a:r>
                <a:r>
                  <a:rPr lang="fr-F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gD</a:t>
                </a:r>
                <a:endParaRPr lang="fr-FR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0E76D73E-54E1-6945-AEF2-A3F23C43AA3B}"/>
                </a:ext>
              </a:extLst>
            </p:cNvPr>
            <p:cNvSpPr txBox="1"/>
            <p:nvPr/>
          </p:nvSpPr>
          <p:spPr>
            <a:xfrm>
              <a:off x="3078863" y="4775162"/>
              <a:ext cx="33855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AM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690DF626-A4E7-764B-A511-F6564768F3EC}"/>
                </a:ext>
              </a:extLst>
            </p:cNvPr>
            <p:cNvSpPr txBox="1"/>
            <p:nvPr/>
          </p:nvSpPr>
          <p:spPr>
            <a:xfrm>
              <a:off x="1871093" y="4813262"/>
              <a:ext cx="3898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TLM</a:t>
              </a:r>
            </a:p>
          </p:txBody>
        </p:sp>
      </p:grpSp>
      <p:cxnSp>
        <p:nvCxnSpPr>
          <p:cNvPr id="16" name="Connecteur droit avec flèche 15">
            <a:extLst>
              <a:ext uri="{FF2B5EF4-FFF2-40B4-BE49-F238E27FC236}">
                <a16:creationId xmlns:a16="http://schemas.microsoft.com/office/drawing/2014/main" id="{AB2D5D13-CB92-9949-985A-02DBD42684E8}"/>
              </a:ext>
            </a:extLst>
          </p:cNvPr>
          <p:cNvCxnSpPr>
            <a:cxnSpLocks/>
          </p:cNvCxnSpPr>
          <p:nvPr/>
        </p:nvCxnSpPr>
        <p:spPr>
          <a:xfrm>
            <a:off x="5221915" y="2636394"/>
            <a:ext cx="0" cy="75831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3FB82175-54BF-8B48-8A81-5976D6F3B144}"/>
              </a:ext>
            </a:extLst>
          </p:cNvPr>
          <p:cNvCxnSpPr>
            <a:cxnSpLocks/>
          </p:cNvCxnSpPr>
          <p:nvPr/>
        </p:nvCxnSpPr>
        <p:spPr>
          <a:xfrm flipV="1">
            <a:off x="3198844" y="4402914"/>
            <a:ext cx="934247" cy="1"/>
          </a:xfrm>
          <a:prstGeom prst="straightConnector1">
            <a:avLst/>
          </a:prstGeom>
          <a:ln w="28575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AE670027-52E9-0242-877B-8BD6F459A9D1}"/>
              </a:ext>
            </a:extLst>
          </p:cNvPr>
          <p:cNvSpPr/>
          <p:nvPr/>
        </p:nvSpPr>
        <p:spPr>
          <a:xfrm>
            <a:off x="1752658" y="5211230"/>
            <a:ext cx="5675255" cy="1387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3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Gating strategy for the identification of B-cell subsets in lymphoid organs.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Panel 5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Table S2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 was used to analyse the composition of the B-cell pool present in spleen and terminal ileum. Representative dot plots showing gating strategy used to identify various subsets in live CD45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B-cells: GC B-cells expressing CD20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and Bcl6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,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within Bcl6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B-cells, naïve B cells (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, MZ B cells (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hi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, resting memory B-cells (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, activated memory (AM, 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 and tissue-like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memory (TLM, SIgD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1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CD27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) B-cells. 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9005532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16</Words>
  <Application>Microsoft Macintosh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RICHARD</dc:creator>
  <cp:lastModifiedBy>Yolande RICHARD</cp:lastModifiedBy>
  <cp:revision>7</cp:revision>
  <dcterms:created xsi:type="dcterms:W3CDTF">2019-08-06T10:11:46Z</dcterms:created>
  <dcterms:modified xsi:type="dcterms:W3CDTF">2020-01-27T09:56:37Z</dcterms:modified>
</cp:coreProperties>
</file>